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1DDB592-4251-381B-6D68-817A2989ED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72134BA4-738C-AED2-082C-1CCCAB7737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2EADFBA-79C5-B46D-4000-E9CD97591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46DE21B-06ED-5FAC-F6D4-7CF98E24F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428B5AF-E940-E161-1E84-D510F7BB9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95064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F0465DC-2BC2-5A46-233A-06641D524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75C579D2-7277-9B2D-1C3D-9CB407DC0B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A4C6610-9E7F-6B07-4E82-6C1CB0F40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0B002988-29E0-8312-7D2F-28F84244D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E2297AE-D366-96D5-CB9C-82D3F1A31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0749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789A8A39-4891-E937-AA13-D4EF530415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DA21FFB7-87A9-1E6B-F5DF-C26BE5ED86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2018940-2C67-8211-4AB3-12C8D6889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97D1632-F4A0-073F-DA9C-B367B1CF1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B46CBBF-B8DA-1884-E682-7D5E7515A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03755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A5C1869-4B49-FF7B-B7B2-2A236CABD2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A7BAE03C-D54D-BC98-B804-CD4A2F6FFA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AB30A0F-6BDC-BFAF-9E9F-73318CEBF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F6FFCB9-B3A6-4A64-5D05-741A37EB6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B6E166D-A46C-D15E-B2E2-F21668EB1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1686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F3DB165-27C1-2397-F89D-35A0D6F6B9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C0466FA-A466-34C7-057F-35F5626229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FC17810-0A4A-32C7-86F1-A5CE738C0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BB14DC8-91A3-E6FE-D395-D2DA426E5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80D6EB7-51CA-2883-B474-57AEBE42B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82646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AB36E7C-1EC6-F753-C1D2-0D76ED55E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CF04947-AE6F-1630-E490-13A75140B2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87672790-0D7A-AB10-F8F7-B7F0582FBB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66438FC0-6D39-4992-BFFB-4F7FABF0A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43E93B1-86AA-F752-7950-620D6B632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E87369D6-CDC5-3C09-CA5E-3E6E7F6BC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9211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8BDEDC4-5024-DF6C-7116-D247827B0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FC8AEB06-9F69-3248-47DD-2D38ED0756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F698912F-2EBB-35A4-A68E-085B398079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C5A88BFD-F6F0-93CF-D136-FE4A026B97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4223D82A-8B34-C536-70FA-AC1299C975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BDDA93F0-2C66-254F-407F-58BA8901E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C67D89AC-3CDC-F0AE-93C5-FD3EE2C15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CA6DC16A-E79E-3178-3EB8-6D842E855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7774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010FA06-C7ED-1FA9-A844-04C956419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BD935FCC-4DA4-6871-0025-DEB8C861F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1A62BB35-AFE1-C38B-6B18-B4BC7BF86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4E85F7F4-BD0B-EFE7-B256-AE826DDAD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22638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E2856C2E-9124-0D0A-48DC-8298F05E6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4F6656FD-6548-A168-E77D-DF6F2599F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C89064AF-4CB0-0170-0ECB-52755DD4B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15673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675004B-BD6F-4B8D-29CB-BE966CE73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78EFA28D-FA6F-7755-2066-92BDEF5CE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3DB0F09F-102F-BB7F-E49F-1CC6560532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842C4DCB-C14C-D6F2-80ED-16AA258E1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56DEFDF-8C68-E740-7242-38D0DB4D6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CC20336-65FE-43D8-B511-FF6D2B71E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40849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F4DAB1C-724A-7D51-1FBC-9A60E564C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903300A6-48A5-03C6-83AB-C41A12A0B4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45C006A6-719C-4B0A-0C7E-01B0ECE51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FED0F16-95EE-4AC3-A78C-E274F9755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918C1F15-29A5-5DFB-9069-F3D7B7D12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826DDDA0-33E1-4F81-10FD-8BA42619B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68763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C31190DC-E12E-6DB3-62FB-73323D011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5C4D824-F6D7-9729-7F70-0CA764424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784619C-C64C-4B48-6CC6-A20796BA0C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86D1F-0D5F-437C-9C93-743AEB7BF493}" type="datetimeFigureOut">
              <a:rPr lang="hu-HU" smtClean="0"/>
              <a:t>2023. 04. 1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CD4251C-4E53-186B-DE74-1ED6DEC475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382A98F-B0E1-CC74-48F0-3AD4B2D837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0B2FFE-3BB0-476B-A781-9BC7B18D820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0332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Csoportba foglalás 5">
            <a:extLst>
              <a:ext uri="{FF2B5EF4-FFF2-40B4-BE49-F238E27FC236}">
                <a16:creationId xmlns:a16="http://schemas.microsoft.com/office/drawing/2014/main" id="{94648409-D9F8-4646-EE98-84C9BBD4CC84}"/>
              </a:ext>
            </a:extLst>
          </p:cNvPr>
          <p:cNvGrpSpPr/>
          <p:nvPr/>
        </p:nvGrpSpPr>
        <p:grpSpPr>
          <a:xfrm>
            <a:off x="3518162" y="768535"/>
            <a:ext cx="4646334" cy="5081849"/>
            <a:chOff x="3642450" y="670881"/>
            <a:chExt cx="4646334" cy="5081849"/>
          </a:xfrm>
        </p:grpSpPr>
        <p:grpSp>
          <p:nvGrpSpPr>
            <p:cNvPr id="3" name="Csoportba foglalás 2">
              <a:extLst>
                <a:ext uri="{FF2B5EF4-FFF2-40B4-BE49-F238E27FC236}">
                  <a16:creationId xmlns:a16="http://schemas.microsoft.com/office/drawing/2014/main" id="{9A5DBE5C-232C-4FA4-17A7-68844E046B2F}"/>
                </a:ext>
              </a:extLst>
            </p:cNvPr>
            <p:cNvGrpSpPr/>
            <p:nvPr/>
          </p:nvGrpSpPr>
          <p:grpSpPr>
            <a:xfrm>
              <a:off x="3642450" y="670881"/>
              <a:ext cx="4646334" cy="5081849"/>
              <a:chOff x="3733800" y="395673"/>
              <a:chExt cx="4646334" cy="5081849"/>
            </a:xfrm>
          </p:grpSpPr>
          <p:grpSp>
            <p:nvGrpSpPr>
              <p:cNvPr id="12" name="Csoportba foglalás 11">
                <a:extLst>
                  <a:ext uri="{FF2B5EF4-FFF2-40B4-BE49-F238E27FC236}">
                    <a16:creationId xmlns:a16="http://schemas.microsoft.com/office/drawing/2014/main" id="{1331F9BE-33CC-DF2C-9CAC-E2FA271EEC98}"/>
                  </a:ext>
                </a:extLst>
              </p:cNvPr>
              <p:cNvGrpSpPr/>
              <p:nvPr/>
            </p:nvGrpSpPr>
            <p:grpSpPr>
              <a:xfrm>
                <a:off x="3739717" y="395673"/>
                <a:ext cx="4640417" cy="5081849"/>
                <a:chOff x="3739717" y="395673"/>
                <a:chExt cx="4640417" cy="5081849"/>
              </a:xfrm>
            </p:grpSpPr>
            <p:pic>
              <p:nvPicPr>
                <p:cNvPr id="5" name="Kép 4">
                  <a:extLst>
                    <a:ext uri="{FF2B5EF4-FFF2-40B4-BE49-F238E27FC236}">
                      <a16:creationId xmlns:a16="http://schemas.microsoft.com/office/drawing/2014/main" id="{A22D372A-408F-4135-29F7-1AAFC66BF0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39717" y="395673"/>
                  <a:ext cx="4435247" cy="5081849"/>
                </a:xfrm>
                <a:prstGeom prst="rect">
                  <a:avLst/>
                </a:prstGeom>
              </p:spPr>
            </p:pic>
            <p:sp>
              <p:nvSpPr>
                <p:cNvPr id="8" name="Szövegdoboz 7">
                  <a:extLst>
                    <a:ext uri="{FF2B5EF4-FFF2-40B4-BE49-F238E27FC236}">
                      <a16:creationId xmlns:a16="http://schemas.microsoft.com/office/drawing/2014/main" id="{CF9B0E2C-2F8E-3E55-C45A-474A4F9A8844}"/>
                    </a:ext>
                  </a:extLst>
                </p:cNvPr>
                <p:cNvSpPr txBox="1"/>
                <p:nvPr/>
              </p:nvSpPr>
              <p:spPr>
                <a:xfrm>
                  <a:off x="4841564" y="4649495"/>
                  <a:ext cx="3538570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400" dirty="0" err="1"/>
                    <a:t>Control</a:t>
                  </a:r>
                  <a:r>
                    <a:rPr lang="hu-HU" sz="1400" dirty="0"/>
                    <a:t> </a:t>
                  </a:r>
                  <a:r>
                    <a:rPr lang="hu-HU" sz="1400" dirty="0" err="1"/>
                    <a:t>strain</a:t>
                  </a:r>
                  <a:r>
                    <a:rPr lang="hu-HU" sz="1400" dirty="0"/>
                    <a:t>        </a:t>
                  </a:r>
                  <a:r>
                    <a:rPr lang="hu-HU" sz="1400" i="1" dirty="0"/>
                    <a:t>lig4</a:t>
                  </a:r>
                  <a:r>
                    <a:rPr lang="hu-HU" sz="1400" dirty="0"/>
                    <a:t> </a:t>
                  </a:r>
                  <a:r>
                    <a:rPr lang="hu-HU" sz="1400" dirty="0" err="1"/>
                    <a:t>disrupted</a:t>
                  </a:r>
                  <a:r>
                    <a:rPr lang="hu-HU" sz="1400" dirty="0"/>
                    <a:t>  </a:t>
                  </a:r>
                  <a:r>
                    <a:rPr lang="hu-HU" sz="1400" dirty="0" err="1"/>
                    <a:t>strain</a:t>
                  </a:r>
                  <a:endParaRPr lang="hu-HU" sz="1400" dirty="0"/>
                </a:p>
              </p:txBody>
            </p:sp>
            <p:pic>
              <p:nvPicPr>
                <p:cNvPr id="10" name="Kép 9">
                  <a:extLst>
                    <a:ext uri="{FF2B5EF4-FFF2-40B4-BE49-F238E27FC236}">
                      <a16:creationId xmlns:a16="http://schemas.microsoft.com/office/drawing/2014/main" id="{72278AB2-7E59-49C8-7450-EEFB7CE351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4433" t="28286" r="45795" b="66808"/>
                <a:stretch/>
              </p:blipFill>
              <p:spPr>
                <a:xfrm>
                  <a:off x="5121046" y="5024336"/>
                  <a:ext cx="3053918" cy="453185"/>
                </a:xfrm>
                <a:prstGeom prst="rect">
                  <a:avLst/>
                </a:prstGeom>
              </p:spPr>
            </p:pic>
          </p:grpSp>
          <p:sp>
            <p:nvSpPr>
              <p:cNvPr id="2" name="Szövegdoboz 1">
                <a:extLst>
                  <a:ext uri="{FF2B5EF4-FFF2-40B4-BE49-F238E27FC236}">
                    <a16:creationId xmlns:a16="http://schemas.microsoft.com/office/drawing/2014/main" id="{78757358-E254-EFDC-62CC-4DF66D8897C3}"/>
                  </a:ext>
                </a:extLst>
              </p:cNvPr>
              <p:cNvSpPr txBox="1"/>
              <p:nvPr/>
            </p:nvSpPr>
            <p:spPr>
              <a:xfrm>
                <a:off x="3733800" y="4244340"/>
                <a:ext cx="304800" cy="5334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hu-HU" dirty="0"/>
              </a:p>
            </p:txBody>
          </p:sp>
        </p:grpSp>
        <p:sp>
          <p:nvSpPr>
            <p:cNvPr id="4" name="Szövegdoboz 3">
              <a:extLst>
                <a:ext uri="{FF2B5EF4-FFF2-40B4-BE49-F238E27FC236}">
                  <a16:creationId xmlns:a16="http://schemas.microsoft.com/office/drawing/2014/main" id="{40042957-7142-69CC-2D5A-B918190E2807}"/>
                </a:ext>
              </a:extLst>
            </p:cNvPr>
            <p:cNvSpPr txBox="1"/>
            <p:nvPr/>
          </p:nvSpPr>
          <p:spPr>
            <a:xfrm>
              <a:off x="3912400" y="766716"/>
              <a:ext cx="5504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600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51003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Csoportba foglalás 22">
            <a:extLst>
              <a:ext uri="{FF2B5EF4-FFF2-40B4-BE49-F238E27FC236}">
                <a16:creationId xmlns:a16="http://schemas.microsoft.com/office/drawing/2014/main" id="{A86A197B-9DCD-456D-F33B-957AEFFF7EDF}"/>
              </a:ext>
            </a:extLst>
          </p:cNvPr>
          <p:cNvGrpSpPr/>
          <p:nvPr/>
        </p:nvGrpSpPr>
        <p:grpSpPr>
          <a:xfrm>
            <a:off x="512727" y="232003"/>
            <a:ext cx="11156927" cy="6438276"/>
            <a:chOff x="708036" y="169859"/>
            <a:chExt cx="11156927" cy="6438276"/>
          </a:xfrm>
        </p:grpSpPr>
        <p:grpSp>
          <p:nvGrpSpPr>
            <p:cNvPr id="22" name="Csoportba foglalás 21">
              <a:extLst>
                <a:ext uri="{FF2B5EF4-FFF2-40B4-BE49-F238E27FC236}">
                  <a16:creationId xmlns:a16="http://schemas.microsoft.com/office/drawing/2014/main" id="{27A3C1B6-BE39-B164-0F84-0C88C2CEAE8A}"/>
                </a:ext>
              </a:extLst>
            </p:cNvPr>
            <p:cNvGrpSpPr/>
            <p:nvPr/>
          </p:nvGrpSpPr>
          <p:grpSpPr>
            <a:xfrm>
              <a:off x="708036" y="169859"/>
              <a:ext cx="11156927" cy="6438276"/>
              <a:chOff x="601504" y="386806"/>
              <a:chExt cx="11156927" cy="6438276"/>
            </a:xfrm>
          </p:grpSpPr>
          <p:grpSp>
            <p:nvGrpSpPr>
              <p:cNvPr id="19" name="Csoportba foglalás 18">
                <a:extLst>
                  <a:ext uri="{FF2B5EF4-FFF2-40B4-BE49-F238E27FC236}">
                    <a16:creationId xmlns:a16="http://schemas.microsoft.com/office/drawing/2014/main" id="{F17D70A6-6BE4-52F6-54AF-503D9CBC9A3B}"/>
                  </a:ext>
                </a:extLst>
              </p:cNvPr>
              <p:cNvGrpSpPr/>
              <p:nvPr/>
            </p:nvGrpSpPr>
            <p:grpSpPr>
              <a:xfrm>
                <a:off x="601504" y="386806"/>
                <a:ext cx="11156927" cy="6438276"/>
                <a:chOff x="601504" y="386806"/>
                <a:chExt cx="11156927" cy="6438276"/>
              </a:xfrm>
            </p:grpSpPr>
            <p:grpSp>
              <p:nvGrpSpPr>
                <p:cNvPr id="4" name="Csoportba foglalás 3"/>
                <p:cNvGrpSpPr/>
                <p:nvPr/>
              </p:nvGrpSpPr>
              <p:grpSpPr>
                <a:xfrm>
                  <a:off x="685800" y="756138"/>
                  <a:ext cx="10647485" cy="1406770"/>
                  <a:chOff x="685800" y="756138"/>
                  <a:chExt cx="10647485" cy="1406770"/>
                </a:xfrm>
              </p:grpSpPr>
              <p:pic>
                <p:nvPicPr>
                  <p:cNvPr id="5" name="Kép 4">
                    <a:extLst>
                      <a:ext uri="{FF2B5EF4-FFF2-40B4-BE49-F238E27FC236}">
                        <a16:creationId xmlns:a16="http://schemas.microsoft.com/office/drawing/2014/main" id="{A0E4CB23-911A-2CD2-18EE-372FDBCDFE1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5625" t="11026" r="7043" b="72179"/>
                  <a:stretch/>
                </p:blipFill>
                <p:spPr>
                  <a:xfrm>
                    <a:off x="685800" y="756138"/>
                    <a:ext cx="10647485" cy="1151793"/>
                  </a:xfrm>
                  <a:prstGeom prst="rect">
                    <a:avLst/>
                  </a:prstGeom>
                </p:spPr>
              </p:pic>
              <p:pic>
                <p:nvPicPr>
                  <p:cNvPr id="6" name="Kép 5">
                    <a:extLst>
                      <a:ext uri="{FF2B5EF4-FFF2-40B4-BE49-F238E27FC236}">
                        <a16:creationId xmlns:a16="http://schemas.microsoft.com/office/drawing/2014/main" id="{A0E4CB23-911A-2CD2-18EE-372FDBCDFE1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5625" t="47179" r="7115" b="49231"/>
                  <a:stretch/>
                </p:blipFill>
                <p:spPr>
                  <a:xfrm>
                    <a:off x="685800" y="1916723"/>
                    <a:ext cx="10638692" cy="24618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7" name="Szövegdoboz 6"/>
                <p:cNvSpPr txBox="1"/>
                <p:nvPr/>
              </p:nvSpPr>
              <p:spPr>
                <a:xfrm>
                  <a:off x="3590002" y="386806"/>
                  <a:ext cx="550343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i="1" dirty="0"/>
                    <a:t>lig4</a:t>
                  </a:r>
                  <a:r>
                    <a:rPr lang="en-AU" dirty="0"/>
                    <a:t> RNA expression and coverage in the wild-type strain </a:t>
                  </a:r>
                </a:p>
              </p:txBody>
            </p:sp>
            <p:sp>
              <p:nvSpPr>
                <p:cNvPr id="9" name="Szövegdoboz 8"/>
                <p:cNvSpPr txBox="1"/>
                <p:nvPr/>
              </p:nvSpPr>
              <p:spPr>
                <a:xfrm>
                  <a:off x="9954381" y="2189201"/>
                  <a:ext cx="77136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dirty="0"/>
                    <a:t>5’ end</a:t>
                  </a:r>
                </a:p>
              </p:txBody>
            </p:sp>
            <p:sp>
              <p:nvSpPr>
                <p:cNvPr id="10" name="Szövegdoboz 9"/>
                <p:cNvSpPr txBox="1"/>
                <p:nvPr/>
              </p:nvSpPr>
              <p:spPr>
                <a:xfrm>
                  <a:off x="685800" y="2189201"/>
                  <a:ext cx="77136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dirty="0"/>
                    <a:t>3’ end</a:t>
                  </a:r>
                </a:p>
              </p:txBody>
            </p:sp>
            <p:sp>
              <p:nvSpPr>
                <p:cNvPr id="2" name="Szövegdoboz 1">
                  <a:extLst>
                    <a:ext uri="{FF2B5EF4-FFF2-40B4-BE49-F238E27FC236}">
                      <a16:creationId xmlns:a16="http://schemas.microsoft.com/office/drawing/2014/main" id="{DEA15251-5EB4-23CF-EE79-E20E7083E40B}"/>
                    </a:ext>
                  </a:extLst>
                </p:cNvPr>
                <p:cNvSpPr txBox="1"/>
                <p:nvPr/>
              </p:nvSpPr>
              <p:spPr>
                <a:xfrm>
                  <a:off x="685800" y="474868"/>
                  <a:ext cx="53849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600" dirty="0"/>
                    <a:t>B</a:t>
                  </a:r>
                </a:p>
              </p:txBody>
            </p:sp>
            <p:sp>
              <p:nvSpPr>
                <p:cNvPr id="3" name="Szövegdoboz 2">
                  <a:extLst>
                    <a:ext uri="{FF2B5EF4-FFF2-40B4-BE49-F238E27FC236}">
                      <a16:creationId xmlns:a16="http://schemas.microsoft.com/office/drawing/2014/main" id="{7901CE25-9358-C222-87DA-2A75353F99F7}"/>
                    </a:ext>
                  </a:extLst>
                </p:cNvPr>
                <p:cNvSpPr txBox="1"/>
                <p:nvPr/>
              </p:nvSpPr>
              <p:spPr>
                <a:xfrm>
                  <a:off x="601504" y="6206451"/>
                  <a:ext cx="11156927" cy="618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1890395" indent="-234315">
                    <a:lnSpc>
                      <a:spcPct val="95000"/>
                    </a:lnSpc>
                    <a:spcAft>
                      <a:spcPts val="600"/>
                    </a:spcAft>
                  </a:pPr>
                  <a:r>
                    <a:rPr lang="en-US" sz="18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igure S5. Heatmap obtained from the RNA sequencing normalized data (A), and coverage of the </a:t>
                  </a:r>
                  <a:r>
                    <a:rPr lang="en-US" sz="1800" i="1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lig4 </a:t>
                  </a:r>
                  <a:r>
                    <a:rPr lang="en-US" sz="180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ene </a:t>
                  </a:r>
                  <a:r>
                    <a:rPr lang="en-US" sz="1800" dirty="0"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(B,C).</a:t>
                  </a:r>
                  <a:endParaRPr lang="en-AU" dirty="0"/>
                </a:p>
              </p:txBody>
            </p:sp>
          </p:grpSp>
          <p:grpSp>
            <p:nvGrpSpPr>
              <p:cNvPr id="21" name="Csoportba foglalás 20">
                <a:extLst>
                  <a:ext uri="{FF2B5EF4-FFF2-40B4-BE49-F238E27FC236}">
                    <a16:creationId xmlns:a16="http://schemas.microsoft.com/office/drawing/2014/main" id="{251DDA97-488D-D962-ED69-22A61769FAB0}"/>
                  </a:ext>
                </a:extLst>
              </p:cNvPr>
              <p:cNvGrpSpPr/>
              <p:nvPr/>
            </p:nvGrpSpPr>
            <p:grpSpPr>
              <a:xfrm>
                <a:off x="665725" y="2492367"/>
                <a:ext cx="10647485" cy="3602006"/>
                <a:chOff x="665725" y="2492367"/>
                <a:chExt cx="10647485" cy="3602006"/>
              </a:xfrm>
            </p:grpSpPr>
            <p:pic>
              <p:nvPicPr>
                <p:cNvPr id="8" name="Kép 7">
                  <a:extLst>
                    <a:ext uri="{FF2B5EF4-FFF2-40B4-BE49-F238E27FC236}">
                      <a16:creationId xmlns:a16="http://schemas.microsoft.com/office/drawing/2014/main" id="{D0BB2E6A-7EB6-52EE-321F-1C4CE75DAC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625" t="11154" r="7043" b="49487"/>
                <a:stretch/>
              </p:blipFill>
              <p:spPr>
                <a:xfrm>
                  <a:off x="665725" y="2829208"/>
                  <a:ext cx="10647485" cy="2699239"/>
                </a:xfrm>
                <a:prstGeom prst="rect">
                  <a:avLst/>
                </a:prstGeom>
              </p:spPr>
            </p:pic>
            <p:sp>
              <p:nvSpPr>
                <p:cNvPr id="11" name="Szövegdoboz 10"/>
                <p:cNvSpPr txBox="1"/>
                <p:nvPr/>
              </p:nvSpPr>
              <p:spPr>
                <a:xfrm>
                  <a:off x="3700609" y="2492367"/>
                  <a:ext cx="619579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i="1" dirty="0"/>
                    <a:t>lig4</a:t>
                  </a:r>
                  <a:r>
                    <a:rPr lang="en-AU" dirty="0"/>
                    <a:t> RNA expression and coverage in the </a:t>
                  </a:r>
                  <a:r>
                    <a:rPr lang="en-AU" i="1" dirty="0"/>
                    <a:t>lig4 </a:t>
                  </a:r>
                  <a:r>
                    <a:rPr lang="en-AU" dirty="0"/>
                    <a:t>mutant strain</a:t>
                  </a:r>
                  <a:r>
                    <a:rPr lang="hu-HU" dirty="0"/>
                    <a:t> (</a:t>
                  </a:r>
                  <a:r>
                    <a:rPr lang="en-AU" dirty="0"/>
                    <a:t>334</a:t>
                  </a:r>
                  <a:r>
                    <a:rPr lang="hu-HU" dirty="0"/>
                    <a:t>)</a:t>
                  </a:r>
                  <a:endParaRPr lang="en-AU" dirty="0"/>
                </a:p>
              </p:txBody>
            </p:sp>
            <p:sp>
              <p:nvSpPr>
                <p:cNvPr id="16" name="Szövegdoboz 15"/>
                <p:cNvSpPr txBox="1"/>
                <p:nvPr/>
              </p:nvSpPr>
              <p:spPr>
                <a:xfrm>
                  <a:off x="4281177" y="5725041"/>
                  <a:ext cx="433650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dirty="0"/>
                    <a:t>Red line: position of the KanMX6 integration</a:t>
                  </a:r>
                </a:p>
              </p:txBody>
            </p:sp>
            <p:sp>
              <p:nvSpPr>
                <p:cNvPr id="12" name="Szövegdoboz 11">
                  <a:extLst>
                    <a:ext uri="{FF2B5EF4-FFF2-40B4-BE49-F238E27FC236}">
                      <a16:creationId xmlns:a16="http://schemas.microsoft.com/office/drawing/2014/main" id="{83BA9521-EF87-2849-8D85-2D951733DF4D}"/>
                    </a:ext>
                  </a:extLst>
                </p:cNvPr>
                <p:cNvSpPr txBox="1"/>
                <p:nvPr/>
              </p:nvSpPr>
              <p:spPr>
                <a:xfrm>
                  <a:off x="677007" y="5528447"/>
                  <a:ext cx="77136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dirty="0"/>
                    <a:t>3’ end</a:t>
                  </a:r>
                </a:p>
              </p:txBody>
            </p:sp>
            <p:sp>
              <p:nvSpPr>
                <p:cNvPr id="14" name="Szövegdoboz 13">
                  <a:extLst>
                    <a:ext uri="{FF2B5EF4-FFF2-40B4-BE49-F238E27FC236}">
                      <a16:creationId xmlns:a16="http://schemas.microsoft.com/office/drawing/2014/main" id="{61545685-DE27-5E2F-7472-2BC0A336F10A}"/>
                    </a:ext>
                  </a:extLst>
                </p:cNvPr>
                <p:cNvSpPr txBox="1"/>
                <p:nvPr/>
              </p:nvSpPr>
              <p:spPr>
                <a:xfrm>
                  <a:off x="10026882" y="5597560"/>
                  <a:ext cx="77136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dirty="0"/>
                    <a:t>5’ end</a:t>
                  </a:r>
                </a:p>
              </p:txBody>
            </p:sp>
            <p:sp>
              <p:nvSpPr>
                <p:cNvPr id="20" name="Szövegdoboz 19">
                  <a:extLst>
                    <a:ext uri="{FF2B5EF4-FFF2-40B4-BE49-F238E27FC236}">
                      <a16:creationId xmlns:a16="http://schemas.microsoft.com/office/drawing/2014/main" id="{9289A8F2-3B7B-D2FF-E2CC-2DDF806038DE}"/>
                    </a:ext>
                  </a:extLst>
                </p:cNvPr>
                <p:cNvSpPr txBox="1"/>
                <p:nvPr/>
              </p:nvSpPr>
              <p:spPr>
                <a:xfrm>
                  <a:off x="685800" y="2544877"/>
                  <a:ext cx="53849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600" dirty="0"/>
                    <a:t>C</a:t>
                  </a:r>
                </a:p>
              </p:txBody>
            </p:sp>
          </p:grpSp>
        </p:grpSp>
        <p:cxnSp>
          <p:nvCxnSpPr>
            <p:cNvPr id="13" name="Egyenes összekötő 12"/>
            <p:cNvCxnSpPr/>
            <p:nvPr/>
          </p:nvCxnSpPr>
          <p:spPr>
            <a:xfrm>
              <a:off x="6261588" y="2861699"/>
              <a:ext cx="24912" cy="2677343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82485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75</Words>
  <Application>Microsoft Office PowerPoint</Application>
  <PresentationFormat>Szélesvásznú</PresentationFormat>
  <Paragraphs>12</Paragraphs>
  <Slides>2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-téma</vt:lpstr>
      <vt:lpstr>PowerPoint-bemutató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álné dr. Miklós Ida</dc:creator>
  <cp:lastModifiedBy>Gálné dr. Miklós Ida</cp:lastModifiedBy>
  <cp:revision>23</cp:revision>
  <dcterms:created xsi:type="dcterms:W3CDTF">2023-01-10T12:23:07Z</dcterms:created>
  <dcterms:modified xsi:type="dcterms:W3CDTF">2023-04-15T13:12:33Z</dcterms:modified>
</cp:coreProperties>
</file>